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83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2C1879-D6C9-9910-6926-411D4D907D8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ECDDBAB-4499-7E9C-2CBA-152034D17FD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26C8D4F-81B1-ECEC-4F88-4A3A43F00A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96E79-2853-44DB-A1E5-4C4B8A6544D2}" type="datetimeFigureOut">
              <a:rPr lang="en-US" smtClean="0"/>
              <a:t>1/30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C0A1A9B-FB96-E215-78F0-7FEAC9EC27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36F2234-9151-363E-F64D-253E79755E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2B403-0611-4B85-A220-89AD3051B3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82618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1C0A16-1918-F153-E67C-7C3439921FD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A1B8941-0770-4701-C02F-CFA48A9C78F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E12E164-650A-68C6-3C17-55F3868738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96E79-2853-44DB-A1E5-4C4B8A6544D2}" type="datetimeFigureOut">
              <a:rPr lang="en-US" smtClean="0"/>
              <a:t>1/30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693BFA4-BD8F-19F7-A322-AF516D229B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4EB34B0-A279-29FD-2201-01C6411786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2B403-0611-4B85-A220-89AD3051B3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56072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3A6A681-437C-4A0B-5C7D-34C82F1C004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D40E2F8-5FF6-4ADC-3689-5FB5D1556C1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610C8D6-5030-4D32-A218-D38AC25337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96E79-2853-44DB-A1E5-4C4B8A6544D2}" type="datetimeFigureOut">
              <a:rPr lang="en-US" smtClean="0"/>
              <a:t>1/30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F0F51AE-B900-8B30-C5DD-65D93C533A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5BFDDA1-F3A0-E6C8-E262-4FA291D468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2B403-0611-4B85-A220-89AD3051B3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23446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189F36-E70E-AE64-84DC-58F67BEFED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17A9C2D-F3C6-7BA9-B675-B02F834C080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102AD24-4E9D-88AF-8A73-016D3C57AF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96E79-2853-44DB-A1E5-4C4B8A6544D2}" type="datetimeFigureOut">
              <a:rPr lang="en-US" smtClean="0"/>
              <a:t>1/30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4316865-A0F6-C15F-CD71-1F682AA3C9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433DE85-026D-D071-BBDC-3F13639763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2B403-0611-4B85-A220-89AD3051B3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25414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B26336-A0D2-4ED4-7424-26227FEAD9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98C0D25-E098-3D1F-F411-9D49FD10776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A3DCE90-2E2D-0B35-9239-899DC02171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96E79-2853-44DB-A1E5-4C4B8A6544D2}" type="datetimeFigureOut">
              <a:rPr lang="en-US" smtClean="0"/>
              <a:t>1/30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2F4D96-03D6-D14D-DA59-59007BC223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6AF6F26-E321-03D6-1158-F3CAE28D83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2B403-0611-4B85-A220-89AD3051B3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13216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A82872-8DDD-0CA1-BF2B-6D9F674F0C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BC8CD95-E6DE-1DEE-EE0E-97FB47AFDCC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6D5BB59-D298-B569-D1DC-C58BF5B0AF8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E2DAFD1-A808-B014-593A-899EC733AD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96E79-2853-44DB-A1E5-4C4B8A6544D2}" type="datetimeFigureOut">
              <a:rPr lang="en-US" smtClean="0"/>
              <a:t>1/30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79DEA0A-6693-D0CA-1F7F-22DF0FB129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00602B9-00C7-B331-2A91-1CECB6902D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2B403-0611-4B85-A220-89AD3051B3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1498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978777-2EE4-74B5-95F0-661ABDFDBC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3599970-40F8-7C0E-B142-306D6E51D2D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A05C734-D8D6-E37A-79AB-50AD81CC871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F53243D-AD5A-CCE6-4320-273E8EFE285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DC9027F-D772-536D-1A65-8667C7562B9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641CC8A-B309-EC90-2026-C8D252F64B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96E79-2853-44DB-A1E5-4C4B8A6544D2}" type="datetimeFigureOut">
              <a:rPr lang="en-US" smtClean="0"/>
              <a:t>1/30/20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187DF20-6536-578C-1EB6-ED16842F68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6462B92-6AE9-8BC2-712D-6A27C99F1E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2B403-0611-4B85-A220-89AD3051B3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35809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0435A6-A99E-414E-664F-4328D7CC14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B5802E9-EED5-6B2C-8425-29F376E9FC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96E79-2853-44DB-A1E5-4C4B8A6544D2}" type="datetimeFigureOut">
              <a:rPr lang="en-US" smtClean="0"/>
              <a:t>1/30/20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D88152C-2F86-F07E-294B-DD153C4948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7D57313-9682-7B03-5832-D023EB9D94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2B403-0611-4B85-A220-89AD3051B3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83052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F834611-47B0-F2F8-A754-6B2BAE6365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96E79-2853-44DB-A1E5-4C4B8A6544D2}" type="datetimeFigureOut">
              <a:rPr lang="en-US" smtClean="0"/>
              <a:t>1/30/20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D72A308-C44B-7698-4B22-9645384217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C8FD602-AFBC-1159-1D8B-52E36E2D42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2B403-0611-4B85-A220-89AD3051B3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53535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5257DB-DBE5-A5B9-086A-9555D5F919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94C5054-95A2-A8D0-3E19-CBFF7BA1892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FB1A698-1910-30C5-2E82-808DA23E3BC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BF50C75-0188-2E28-07F8-085448DA12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96E79-2853-44DB-A1E5-4C4B8A6544D2}" type="datetimeFigureOut">
              <a:rPr lang="en-US" smtClean="0"/>
              <a:t>1/30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A693118-F951-7C04-96D7-9485D186B5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A30CBB3-8F30-1CB2-839B-06633B4A49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2B403-0611-4B85-A220-89AD3051B3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24169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2B9571-7D64-4DBE-0602-0E7BB94A83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2908E62-32BD-4272-135C-C5738ED8C06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FEFC0D0-3681-1F56-86C1-091BA47FB38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42F3490-403A-1103-7447-2B2E266A02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96E79-2853-44DB-A1E5-4C4B8A6544D2}" type="datetimeFigureOut">
              <a:rPr lang="en-US" smtClean="0"/>
              <a:t>1/30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D5A8E43-9364-6D46-150C-543C93632C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B0B2FB4-2D1D-ADCB-978C-4A5D95FAC9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2B403-0611-4B85-A220-89AD3051B3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84749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0B7D1B1-E37E-231F-0D6C-F590BF80B5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1655B02-52AB-15E2-7319-678E1728FF1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E7BB36B-A53A-5F6F-8AF1-C68E9423933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6296E79-2853-44DB-A1E5-4C4B8A6544D2}" type="datetimeFigureOut">
              <a:rPr lang="en-US" smtClean="0"/>
              <a:t>1/30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0609689-BAE9-6045-9437-249283B15BA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BC7EEDB-F4B8-2C32-2F2D-F8B2D6E8158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122B403-0611-4B85-A220-89AD3051B3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1635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graph of a patient's disease&#10;&#10;AI-generated content may be incorrect.">
            <a:extLst>
              <a:ext uri="{FF2B5EF4-FFF2-40B4-BE49-F238E27FC236}">
                <a16:creationId xmlns:a16="http://schemas.microsoft.com/office/drawing/2014/main" id="{3F01051B-7895-446A-FF91-E30B4BDE094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786102"/>
            <a:ext cx="12192000" cy="528579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5847161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C71AE0FD-C241-378F-3D38-139E9E917418}"/>
              </a:ext>
            </a:extLst>
          </p:cNvPr>
          <p:cNvSpPr txBox="1"/>
          <p:nvPr/>
        </p:nvSpPr>
        <p:spPr>
          <a:xfrm>
            <a:off x="3048000" y="1325796"/>
            <a:ext cx="6096000" cy="420640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15000"/>
              </a:lnSpc>
              <a:buNone/>
            </a:pPr>
            <a:r>
              <a:rPr lang="en-US" sz="1800" b="1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Supplementary Figure 8</a:t>
            </a:r>
            <a:r>
              <a:rPr lang="en-US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. Recurrence-free survival stratified by ctDNA status within Stage II and Stage III melanoma.</a:t>
            </a:r>
            <a:r>
              <a:rPr lang="en-US" sz="1800" b="1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en-US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(A) Kaplan–Meier recurrence-free survival (RFS) curves for patients with Stage II melanoma, stratified by longitudinal ctDNA status. Patients who were ctDNA-positive at any postoperative timepoint experienced significantly inferior RFS compared with those who remained serially ctDNA-negative throughout follow-up (p &lt; 0.0001). (B) Kaplan–Meier RFS curves for patients with Stage III melanoma, similarly demonstrating markedly shorter RFS among patients who were ctDNA-positive at any postoperative timepoint relative to those with persistently negative ctDNA results (p &lt; 0.0001).</a:t>
            </a:r>
          </a:p>
        </p:txBody>
      </p:sp>
    </p:spTree>
    <p:extLst>
      <p:ext uri="{BB962C8B-B14F-4D97-AF65-F5344CB8AC3E}">
        <p14:creationId xmlns:p14="http://schemas.microsoft.com/office/powerpoint/2010/main" val="25698818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1</Words>
  <Application>Microsoft Office PowerPoint</Application>
  <PresentationFormat>Widescreen</PresentationFormat>
  <Paragraphs>1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ptos</vt:lpstr>
      <vt:lpstr>Aptos Display</vt:lpstr>
      <vt:lpstr>Arial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iegmann, Bill</dc:creator>
  <cp:lastModifiedBy>Siegmann, Bill</cp:lastModifiedBy>
  <cp:revision>1</cp:revision>
  <dcterms:created xsi:type="dcterms:W3CDTF">2026-01-30T20:16:23Z</dcterms:created>
  <dcterms:modified xsi:type="dcterms:W3CDTF">2026-01-30T20:17:01Z</dcterms:modified>
</cp:coreProperties>
</file>